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85D114-8123-4FB6-9648-174C608AB846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B6F8E7-DE09-40C2-ACBB-2BDDC626F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3209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078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315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300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155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40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000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371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006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5203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739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147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55877F-DC37-4587-87C2-17AE81D9681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587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6507031"/>
              </p:ext>
            </p:extLst>
          </p:nvPr>
        </p:nvGraphicFramePr>
        <p:xfrm>
          <a:off x="1343212" y="1540482"/>
          <a:ext cx="9398000" cy="1828800"/>
        </p:xfrm>
        <a:graphic>
          <a:graphicData uri="http://schemas.openxmlformats.org/drawingml/2006/table">
            <a:tbl>
              <a:tblPr firstRow="1" bandRow="1"/>
              <a:tblGrid>
                <a:gridCol w="2349500">
                  <a:extLst>
                    <a:ext uri="{9D8B030D-6E8A-4147-A177-3AD203B41FA5}">
                      <a16:colId xmlns:a16="http://schemas.microsoft.com/office/drawing/2014/main" val="2254087190"/>
                    </a:ext>
                  </a:extLst>
                </a:gridCol>
                <a:gridCol w="2349500">
                  <a:extLst>
                    <a:ext uri="{9D8B030D-6E8A-4147-A177-3AD203B41FA5}">
                      <a16:colId xmlns:a16="http://schemas.microsoft.com/office/drawing/2014/main" val="1180516582"/>
                    </a:ext>
                  </a:extLst>
                </a:gridCol>
                <a:gridCol w="2349500">
                  <a:extLst>
                    <a:ext uri="{9D8B030D-6E8A-4147-A177-3AD203B41FA5}">
                      <a16:colId xmlns:a16="http://schemas.microsoft.com/office/drawing/2014/main" val="1247339581"/>
                    </a:ext>
                  </a:extLst>
                </a:gridCol>
                <a:gridCol w="2349500">
                  <a:extLst>
                    <a:ext uri="{9D8B030D-6E8A-4147-A177-3AD203B41FA5}">
                      <a16:colId xmlns:a16="http://schemas.microsoft.com/office/drawing/2014/main" val="2106835241"/>
                    </a:ext>
                  </a:extLst>
                </a:gridCol>
              </a:tblGrid>
              <a:tr h="3048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utina</a:t>
                      </a:r>
                      <a:r>
                        <a:rPr lang="en-US" sz="18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rugos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utina</a:t>
                      </a:r>
                      <a:r>
                        <a:rPr lang="en-US" sz="18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18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sorugosa</a:t>
                      </a:r>
                      <a:endParaRPr lang="en-US" sz="18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lobasidium</a:t>
                      </a:r>
                      <a:r>
                        <a:rPr lang="en-US" sz="18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gnu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5608022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embly size (Mb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0239208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ig numbe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4381678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L50 (Mb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/3.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/3.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/0.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060612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lete BUSCO (%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2.3 (n</a:t>
                      </a:r>
                      <a:r>
                        <a:rPr lang="en-US" sz="1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</a:t>
                      </a:r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59)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1.6 (n</a:t>
                      </a:r>
                      <a:r>
                        <a:rPr lang="en-US" sz="1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</a:t>
                      </a:r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59)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7.6 (n</a:t>
                      </a:r>
                      <a:r>
                        <a:rPr lang="en-US" sz="1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1335</a:t>
                      </a:r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)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099524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 BUSCO (%)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1566029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255289" y="762267"/>
            <a:ext cx="939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</a:t>
            </a:r>
            <a:r>
              <a:rPr lang="en-US"/>
              <a:t>Table </a:t>
            </a:r>
            <a:r>
              <a:rPr lang="en-US" smtClean="0"/>
              <a:t>S1. </a:t>
            </a:r>
            <a:r>
              <a:rPr lang="en-US" dirty="0"/>
              <a:t>Assembly statistics of the draft genomes of </a:t>
            </a:r>
            <a:r>
              <a:rPr lang="en-AU" sz="1800" i="1" dirty="0" err="1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iutina</a:t>
            </a:r>
            <a:r>
              <a:rPr lang="en-US" i="1" dirty="0"/>
              <a:t> rugosa</a:t>
            </a:r>
            <a:r>
              <a:rPr lang="en-US" dirty="0"/>
              <a:t>, </a:t>
            </a:r>
            <a:r>
              <a:rPr lang="en-AU" sz="1800" i="1" dirty="0" err="1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iutina</a:t>
            </a:r>
            <a:r>
              <a:rPr lang="en-US" i="1" dirty="0"/>
              <a:t> </a:t>
            </a:r>
            <a:r>
              <a:rPr lang="en-US" i="1" dirty="0" err="1"/>
              <a:t>mesorugosa</a:t>
            </a:r>
            <a:r>
              <a:rPr lang="en-US" i="1" dirty="0"/>
              <a:t> </a:t>
            </a:r>
            <a:r>
              <a:rPr lang="en-US" dirty="0"/>
              <a:t>and </a:t>
            </a:r>
            <a:r>
              <a:rPr lang="en-US" i="1" dirty="0" err="1"/>
              <a:t>Filobasidium</a:t>
            </a:r>
            <a:r>
              <a:rPr lang="en-US" i="1" dirty="0"/>
              <a:t> magnus </a:t>
            </a:r>
            <a:r>
              <a:rPr lang="en-US" dirty="0"/>
              <a:t>in the mock fungal community. </a:t>
            </a:r>
          </a:p>
        </p:txBody>
      </p:sp>
    </p:spTree>
    <p:extLst>
      <p:ext uri="{BB962C8B-B14F-4D97-AF65-F5344CB8AC3E}">
        <p14:creationId xmlns:p14="http://schemas.microsoft.com/office/powerpoint/2010/main" val="2766190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1EF7C38FBB09E4F85BDAAA01A857FC3" ma:contentTypeVersion="13" ma:contentTypeDescription="Create a new document." ma:contentTypeScope="" ma:versionID="462a9eb004de65fad2727f7b025d74ed">
  <xsd:schema xmlns:xsd="http://www.w3.org/2001/XMLSchema" xmlns:xs="http://www.w3.org/2001/XMLSchema" xmlns:p="http://schemas.microsoft.com/office/2006/metadata/properties" xmlns:ns3="a0cf5225-6064-4702-9e25-e106cea4ec30" xmlns:ns4="75e521d4-4013-45d9-ac7e-9eb842c0f228" targetNamespace="http://schemas.microsoft.com/office/2006/metadata/properties" ma:root="true" ma:fieldsID="385c780b75cbf956706aadcb38b7f192" ns3:_="" ns4:_="">
    <xsd:import namespace="a0cf5225-6064-4702-9e25-e106cea4ec30"/>
    <xsd:import namespace="75e521d4-4013-45d9-ac7e-9eb842c0f228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AutoKeyPoints" minOccurs="0"/>
                <xsd:element ref="ns4:MediaServiceKeyPoints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0cf5225-6064-4702-9e25-e106cea4ec30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5e521d4-4013-45d9-ac7e-9eb842c0f22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internalName="MediaServiceAutoTags" ma:readOnly="true">
      <xsd:simpleType>
        <xsd:restriction base="dms:Text"/>
      </xsd:simpleType>
    </xsd:element>
    <xsd:element name="MediaServiceOCR" ma:index="14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5B68EE0-6D66-4E4F-9832-33DF095A5149}">
  <ds:schemaRefs>
    <ds:schemaRef ds:uri="75e521d4-4013-45d9-ac7e-9eb842c0f228"/>
    <ds:schemaRef ds:uri="http://purl.org/dc/terms/"/>
    <ds:schemaRef ds:uri="http://schemas.microsoft.com/office/2006/metadata/properties"/>
    <ds:schemaRef ds:uri="http://schemas.openxmlformats.org/package/2006/metadata/core-properties"/>
    <ds:schemaRef ds:uri="http://schemas.microsoft.com/office/2006/documentManagement/types"/>
    <ds:schemaRef ds:uri="http://purl.org/dc/dcmitype/"/>
    <ds:schemaRef ds:uri="http://purl.org/dc/elements/1.1/"/>
    <ds:schemaRef ds:uri="http://schemas.microsoft.com/office/infopath/2007/PartnerControls"/>
    <ds:schemaRef ds:uri="a0cf5225-6064-4702-9e25-e106cea4ec30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AD524537-29CA-40FE-A861-150A6B220F1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8560677-9286-4B62-8C53-F9FC82782BD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0cf5225-6064-4702-9e25-e106cea4ec30"/>
    <ds:schemaRef ds:uri="75e521d4-4013-45d9-ac7e-9eb842c0f22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DengXi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enchmarking community composition  using gold standard analysis</dc:title>
  <dc:creator>Yiheng Hu</dc:creator>
  <cp:lastModifiedBy>Donaldson, Amanda</cp:lastModifiedBy>
  <cp:revision>13</cp:revision>
  <dcterms:created xsi:type="dcterms:W3CDTF">2021-03-24T13:25:26Z</dcterms:created>
  <dcterms:modified xsi:type="dcterms:W3CDTF">2022-03-01T13:16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1EF7C38FBB09E4F85BDAAA01A857FC3</vt:lpwstr>
  </property>
</Properties>
</file>